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91" r:id="rId2"/>
  </p:sldIdLst>
  <p:sldSz cx="7559675" cy="14400213"/>
  <p:notesSz cx="6662738" cy="9926638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905" userDrawn="1">
          <p15:clr>
            <a:srgbClr val="A4A3A4"/>
          </p15:clr>
        </p15:guide>
        <p15:guide id="2" pos="136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DD892"/>
    <a:srgbClr val="D1E0F3"/>
    <a:srgbClr val="C6D9F0"/>
    <a:srgbClr val="99BAE3"/>
    <a:srgbClr val="A2C1E6"/>
    <a:srgbClr val="C1D6EF"/>
    <a:srgbClr val="92C4C3"/>
    <a:srgbClr val="7DB8B6"/>
    <a:srgbClr val="96C6C5"/>
    <a:srgbClr val="E9F3F3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349F8874-E7B7-42F1-BB7D-FF5A491A0CB3}" v="8" dt="2022-04-26T07:55:17.319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3834" autoAdjust="0"/>
    <p:restoredTop sz="96337" autoAdjust="0"/>
  </p:normalViewPr>
  <p:slideViewPr>
    <p:cSldViewPr snapToGrid="0" showGuides="1">
      <p:cViewPr>
        <p:scale>
          <a:sx n="100" d="100"/>
          <a:sy n="100" d="100"/>
        </p:scale>
        <p:origin x="96" y="96"/>
      </p:cViewPr>
      <p:guideLst>
        <p:guide orient="horz" pos="1905"/>
        <p:guide pos="136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microsoft.com/office/2015/10/relationships/revisionInfo" Target="revisionInfo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773488" y="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60DE00BB-2EDC-4267-AE91-B482A1907D02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452688" y="1241425"/>
            <a:ext cx="1757362" cy="334962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66750" y="4776788"/>
            <a:ext cx="5329238" cy="3908425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GB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9429750"/>
            <a:ext cx="2887663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773488" y="9429750"/>
            <a:ext cx="2887662" cy="49688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034C33D-8904-46A7-912A-36A40FF6BAF8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9411415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034C33D-8904-46A7-912A-36A40FF6BAF8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799173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2356703"/>
            <a:ext cx="6425724" cy="5013407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7563446"/>
            <a:ext cx="5669756" cy="3476717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de-DE"/>
              <a:t>Formatvorlage des Untertitelmasters durch Klicken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02305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220370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766678"/>
            <a:ext cx="1630055" cy="12203515"/>
          </a:xfrm>
        </p:spPr>
        <p:txBody>
          <a:bodyPr vert="eaVert"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766678"/>
            <a:ext cx="4795669" cy="12203515"/>
          </a:xfrm>
        </p:spPr>
        <p:txBody>
          <a:bodyPr vert="eaVert"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34690933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4811107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3590057"/>
            <a:ext cx="6520220" cy="5990088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9636813"/>
            <a:ext cx="6520220" cy="3150046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8460182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3833390"/>
            <a:ext cx="3212862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3833390"/>
            <a:ext cx="3212862" cy="9136803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8233309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66681"/>
            <a:ext cx="6520220" cy="2783376"/>
          </a:xfrm>
        </p:spPr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3530053"/>
            <a:ext cx="3198096" cy="1730025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5260078"/>
            <a:ext cx="3198096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3530053"/>
            <a:ext cx="3213847" cy="1730025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5260078"/>
            <a:ext cx="3213847" cy="7736782"/>
          </a:xfrm>
        </p:spPr>
        <p:txBody>
          <a:bodyPr/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5781969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5447883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68402719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960014"/>
            <a:ext cx="2438192" cy="336005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2073367"/>
            <a:ext cx="3827085" cy="10233485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4320064"/>
            <a:ext cx="2438192" cy="8003453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0560336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960014"/>
            <a:ext cx="2438192" cy="3360050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2073367"/>
            <a:ext cx="3827085" cy="10233485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4320064"/>
            <a:ext cx="2438192" cy="8003453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de-DE"/>
              <a:t>Formatvorlagen des Textmasters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710145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766681"/>
            <a:ext cx="6520220" cy="2783376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Titelmasterformat durch Klicken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3833390"/>
            <a:ext cx="6520220" cy="913680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Formatvorlagen des Textmasters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13346867"/>
            <a:ext cx="170092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0555AF-EFA6-47CD-8C79-C1E6F99A178A}" type="datetimeFigureOut">
              <a:rPr lang="en-GB" smtClean="0"/>
              <a:t>07/03/2023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13346867"/>
            <a:ext cx="2551390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13346867"/>
            <a:ext cx="1700927" cy="76667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CE89F26-7812-443B-A68C-CEEF401ABB21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978300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6" name="Gruppieren 5"/>
          <p:cNvGrpSpPr/>
          <p:nvPr/>
        </p:nvGrpSpPr>
        <p:grpSpPr>
          <a:xfrm>
            <a:off x="168376" y="411019"/>
            <a:ext cx="5779093" cy="2855818"/>
            <a:chOff x="438466" y="2135327"/>
            <a:chExt cx="5779093" cy="2855818"/>
          </a:xfrm>
        </p:grpSpPr>
        <p:sp>
          <p:nvSpPr>
            <p:cNvPr id="372" name="Rechteck 371"/>
            <p:cNvSpPr/>
            <p:nvPr/>
          </p:nvSpPr>
          <p:spPr>
            <a:xfrm>
              <a:off x="5159040" y="2165962"/>
              <a:ext cx="270000" cy="2357435"/>
            </a:xfrm>
            <a:prstGeom prst="rect">
              <a:avLst/>
            </a:prstGeom>
            <a:solidFill>
              <a:srgbClr val="FFFFFF">
                <a:lumMod val="95000"/>
              </a:srgbClr>
            </a:solidFill>
            <a:ln w="1587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73" name="Rechteck 372"/>
            <p:cNvSpPr/>
            <p:nvPr/>
          </p:nvSpPr>
          <p:spPr>
            <a:xfrm>
              <a:off x="3500036" y="2165962"/>
              <a:ext cx="270000" cy="2357435"/>
            </a:xfrm>
            <a:prstGeom prst="rect">
              <a:avLst/>
            </a:prstGeom>
            <a:solidFill>
              <a:srgbClr val="FFFFFF">
                <a:lumMod val="95000"/>
              </a:srgbClr>
            </a:solidFill>
            <a:ln w="1587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74" name="Rechteck 373"/>
            <p:cNvSpPr/>
            <p:nvPr/>
          </p:nvSpPr>
          <p:spPr>
            <a:xfrm>
              <a:off x="4301853" y="2165962"/>
              <a:ext cx="270000" cy="2357435"/>
            </a:xfrm>
            <a:prstGeom prst="rect">
              <a:avLst/>
            </a:prstGeom>
            <a:solidFill>
              <a:srgbClr val="FFFFFF">
                <a:lumMod val="95000"/>
              </a:srgbClr>
            </a:solidFill>
            <a:ln w="1587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sp>
          <p:nvSpPr>
            <p:cNvPr id="375" name="Rechteck 374"/>
            <p:cNvSpPr/>
            <p:nvPr/>
          </p:nvSpPr>
          <p:spPr>
            <a:xfrm>
              <a:off x="1320741" y="4403407"/>
              <a:ext cx="4320000" cy="147731"/>
            </a:xfrm>
            <a:prstGeom prst="rect">
              <a:avLst/>
            </a:prstGeom>
            <a:gradFill flip="none" rotWithShape="1">
              <a:gsLst>
                <a:gs pos="2000">
                  <a:srgbClr val="DDD892"/>
                </a:gs>
                <a:gs pos="10000">
                  <a:srgbClr val="DDD892"/>
                </a:gs>
                <a:gs pos="14000">
                  <a:srgbClr val="CE7876">
                    <a:lumMod val="60000"/>
                    <a:lumOff val="40000"/>
                  </a:srgbClr>
                </a:gs>
                <a:gs pos="33000">
                  <a:srgbClr val="CE7876">
                    <a:lumMod val="60000"/>
                    <a:lumOff val="40000"/>
                  </a:srgbClr>
                </a:gs>
                <a:gs pos="47000">
                  <a:srgbClr val="9CBEBD">
                    <a:lumMod val="60000"/>
                    <a:lumOff val="40000"/>
                  </a:srgbClr>
                </a:gs>
              </a:gsLst>
              <a:lin ang="10800000" scaled="1"/>
              <a:tileRect/>
            </a:gradFill>
            <a:ln w="1587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18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376" name="Gerader Verbinder 375"/>
            <p:cNvCxnSpPr/>
            <p:nvPr/>
          </p:nvCxnSpPr>
          <p:spPr>
            <a:xfrm>
              <a:off x="1336240" y="4474665"/>
              <a:ext cx="4284000" cy="1372"/>
            </a:xfrm>
            <a:prstGeom prst="line">
              <a:avLst/>
            </a:prstGeom>
            <a:noFill/>
            <a:ln w="28575" cap="sq" cmpd="sng" algn="ctr">
              <a:solidFill>
                <a:srgbClr val="2E2B21"/>
              </a:solidFill>
              <a:prstDash val="solid"/>
              <a:headEnd type="none" w="med" len="med"/>
              <a:tailEnd type="none" w="med" len="med"/>
            </a:ln>
            <a:effectLst/>
          </p:spPr>
        </p:cxnSp>
        <p:sp>
          <p:nvSpPr>
            <p:cNvPr id="377" name="Textfeld 376"/>
            <p:cNvSpPr txBox="1"/>
            <p:nvPr/>
          </p:nvSpPr>
          <p:spPr>
            <a:xfrm>
              <a:off x="1354401" y="4621812"/>
              <a:ext cx="716224" cy="369332"/>
            </a:xfrm>
            <a:prstGeom prst="rect">
              <a:avLst/>
            </a:prstGeom>
            <a:solidFill>
              <a:srgbClr val="9CBEBD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0" cap="none" spc="0" normalizeH="0" baseline="0" noProof="0" dirty="0">
                  <a:ln>
                    <a:noFill/>
                  </a:ln>
                  <a:solidFill>
                    <a:srgbClr val="2E2B21"/>
                  </a:solidFill>
                  <a:effectLst/>
                  <a:uLnTx/>
                  <a:uFillTx/>
                </a:rPr>
                <a:t>HSPC</a:t>
              </a:r>
            </a:p>
          </p:txBody>
        </p:sp>
        <p:sp>
          <p:nvSpPr>
            <p:cNvPr id="378" name="Textfeld 377"/>
            <p:cNvSpPr txBox="1"/>
            <p:nvPr/>
          </p:nvSpPr>
          <p:spPr>
            <a:xfrm>
              <a:off x="3934840" y="4621813"/>
              <a:ext cx="681638" cy="369332"/>
            </a:xfrm>
            <a:prstGeom prst="rect">
              <a:avLst/>
            </a:prstGeom>
            <a:solidFill>
              <a:srgbClr val="CE7876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0" cap="none" spc="0" normalizeH="0" baseline="0" noProof="0" dirty="0">
                  <a:ln>
                    <a:noFill/>
                  </a:ln>
                  <a:solidFill>
                    <a:srgbClr val="2E2B21"/>
                  </a:solidFill>
                  <a:effectLst/>
                  <a:uLnTx/>
                  <a:uFillTx/>
                </a:rPr>
                <a:t>CRPC</a:t>
              </a:r>
            </a:p>
          </p:txBody>
        </p:sp>
        <p:sp>
          <p:nvSpPr>
            <p:cNvPr id="379" name="Textfeld 378"/>
            <p:cNvSpPr txBox="1"/>
            <p:nvPr/>
          </p:nvSpPr>
          <p:spPr>
            <a:xfrm>
              <a:off x="5584565" y="2808025"/>
              <a:ext cx="632994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FFFFFF">
                      <a:lumMod val="50000"/>
                    </a:srgbClr>
                  </a:solidFill>
                  <a:effectLst/>
                  <a:uLnTx/>
                  <a:uFillTx/>
                </a:rPr>
                <a:t>Tumor</a:t>
              </a:r>
              <a:r>
                <a:rPr kumimoji="0" lang="en-GB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95A39D">
                      <a:lumMod val="75000"/>
                    </a:srgbClr>
                  </a:solidFill>
                  <a:effectLst/>
                  <a:uLnTx/>
                  <a:uFillTx/>
                </a:rPr>
                <a:t> </a:t>
              </a:r>
            </a:p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95A39D">
                      <a:lumMod val="75000"/>
                    </a:srgbClr>
                  </a:solidFill>
                  <a:effectLst/>
                  <a:uLnTx/>
                  <a:uFillTx/>
                </a:rPr>
                <a:t>burden</a:t>
              </a:r>
            </a:p>
          </p:txBody>
        </p:sp>
        <p:sp>
          <p:nvSpPr>
            <p:cNvPr id="380" name="Textfeld 379"/>
            <p:cNvSpPr txBox="1"/>
            <p:nvPr/>
          </p:nvSpPr>
          <p:spPr>
            <a:xfrm>
              <a:off x="1594546" y="3139137"/>
              <a:ext cx="687948" cy="46166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600"/>
              </a:lvl1pPr>
            </a:lstStyle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FFFF">
                      <a:lumMod val="50000"/>
                    </a:srgbClr>
                  </a:solidFill>
                  <a:effectLst/>
                  <a:uLnTx/>
                  <a:uFillTx/>
                </a:rPr>
                <a:t>Primary</a:t>
              </a:r>
            </a:p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FFFF">
                      <a:lumMod val="50000"/>
                    </a:srgbClr>
                  </a:solidFill>
                  <a:effectLst/>
                  <a:uLnTx/>
                  <a:uFillTx/>
                </a:rPr>
                <a:t> </a:t>
              </a:r>
              <a:r>
                <a:rPr kumimoji="0" lang="en-GB" sz="12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FFFFFF">
                      <a:lumMod val="50000"/>
                    </a:srgbClr>
                  </a:solidFill>
                  <a:effectLst/>
                  <a:uLnTx/>
                  <a:uFillTx/>
                </a:rPr>
                <a:t>tumor</a:t>
              </a:r>
              <a:endParaRPr kumimoji="0" lang="en-GB" sz="1200" b="0" i="0" u="none" strike="noStrike" kern="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</a:endParaRPr>
            </a:p>
          </p:txBody>
        </p:sp>
        <p:sp>
          <p:nvSpPr>
            <p:cNvPr id="381" name="Textfeld 380"/>
            <p:cNvSpPr txBox="1"/>
            <p:nvPr/>
          </p:nvSpPr>
          <p:spPr>
            <a:xfrm rot="16200000">
              <a:off x="4982154" y="2284023"/>
              <a:ext cx="614271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0" cap="none" spc="0" normalizeH="0" baseline="0" noProof="0" dirty="0">
                  <a:ln>
                    <a:noFill/>
                  </a:ln>
                  <a:solidFill>
                    <a:srgbClr val="2E2B21"/>
                  </a:solidFill>
                  <a:effectLst/>
                  <a:uLnTx/>
                  <a:uFillTx/>
                </a:rPr>
                <a:t>PC-3</a:t>
              </a:r>
            </a:p>
          </p:txBody>
        </p:sp>
        <p:sp>
          <p:nvSpPr>
            <p:cNvPr id="382" name="Textfeld 381"/>
            <p:cNvSpPr txBox="1"/>
            <p:nvPr/>
          </p:nvSpPr>
          <p:spPr>
            <a:xfrm rot="16200000">
              <a:off x="4061042" y="2331663"/>
              <a:ext cx="762003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0" cap="none" spc="0" normalizeH="0" baseline="0" noProof="0" dirty="0">
                  <a:ln>
                    <a:noFill/>
                  </a:ln>
                  <a:solidFill>
                    <a:srgbClr val="2E2B21"/>
                  </a:solidFill>
                  <a:effectLst/>
                  <a:uLnTx/>
                  <a:uFillTx/>
                </a:rPr>
                <a:t>22Rv1</a:t>
              </a:r>
            </a:p>
          </p:txBody>
        </p:sp>
        <p:sp>
          <p:nvSpPr>
            <p:cNvPr id="383" name="Textfeld 382"/>
            <p:cNvSpPr txBox="1"/>
            <p:nvPr/>
          </p:nvSpPr>
          <p:spPr>
            <a:xfrm>
              <a:off x="5338139" y="4621813"/>
              <a:ext cx="844189" cy="369332"/>
            </a:xfrm>
            <a:prstGeom prst="rect">
              <a:avLst/>
            </a:prstGeom>
            <a:solidFill>
              <a:srgbClr val="C7BE49">
                <a:lumMod val="60000"/>
                <a:lumOff val="40000"/>
              </a:srgbClr>
            </a:solidFill>
          </p:spPr>
          <p:txBody>
            <a:bodyPr wrap="square" rtlCol="0">
              <a:spAutoFit/>
            </a:bodyPr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0" cap="none" spc="0" normalizeH="0" baseline="0" noProof="0" dirty="0">
                  <a:ln>
                    <a:noFill/>
                  </a:ln>
                  <a:solidFill>
                    <a:srgbClr val="2E2B21"/>
                  </a:solidFill>
                  <a:effectLst/>
                  <a:uLnTx/>
                  <a:uFillTx/>
                </a:rPr>
                <a:t>NEDPC</a:t>
              </a:r>
            </a:p>
          </p:txBody>
        </p:sp>
        <p:sp>
          <p:nvSpPr>
            <p:cNvPr id="384" name="Textfeld 383"/>
            <p:cNvSpPr txBox="1"/>
            <p:nvPr/>
          </p:nvSpPr>
          <p:spPr>
            <a:xfrm rot="16200000">
              <a:off x="3239498" y="2342756"/>
              <a:ext cx="784189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marL="0" marR="0" lvl="0" indent="0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8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2E2B21"/>
                  </a:solidFill>
                  <a:effectLst/>
                  <a:uLnTx/>
                  <a:uFillTx/>
                </a:rPr>
                <a:t>LNCaP</a:t>
              </a:r>
              <a:endParaRPr kumimoji="0" lang="en-GB" sz="1800" b="0" i="0" u="none" strike="noStrike" kern="0" cap="none" spc="0" normalizeH="0" baseline="0" noProof="0" dirty="0">
                <a:ln>
                  <a:noFill/>
                </a:ln>
                <a:solidFill>
                  <a:srgbClr val="2E2B21"/>
                </a:solidFill>
                <a:effectLst/>
                <a:uLnTx/>
                <a:uFillTx/>
              </a:endParaRPr>
            </a:p>
          </p:txBody>
        </p:sp>
        <p:sp>
          <p:nvSpPr>
            <p:cNvPr id="386" name="Textfeld 385"/>
            <p:cNvSpPr txBox="1"/>
            <p:nvPr/>
          </p:nvSpPr>
          <p:spPr>
            <a:xfrm>
              <a:off x="438466" y="4507860"/>
              <a:ext cx="859531" cy="46166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de-DE"/>
              </a:defPPr>
              <a:lvl1pPr marR="0" lvl="0" indent="0" algn="ctr" defTabSz="457200" fontAlgn="auto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 sz="1200">
                  <a:solidFill>
                    <a:schemeClr val="bg1">
                      <a:lumMod val="50000"/>
                    </a:schemeClr>
                  </a:solidFill>
                  <a:latin typeface="Calibri" panose="020F0502020204030204"/>
                </a:defRPr>
              </a:lvl1pPr>
            </a:lstStyle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0" cap="none" spc="0" normalizeH="0" baseline="0" noProof="0" dirty="0" smtClean="0">
                  <a:ln>
                    <a:noFill/>
                  </a:ln>
                  <a:solidFill>
                    <a:srgbClr val="FFFFFF">
                      <a:lumMod val="50000"/>
                    </a:srgbClr>
                  </a:solidFill>
                  <a:effectLst/>
                  <a:uLnTx/>
                  <a:uFillTx/>
                  <a:latin typeface="Calibri" panose="020F0502020204030204"/>
                </a:rPr>
                <a:t>Healthy </a:t>
              </a:r>
              <a:endParaRPr kumimoji="0" lang="en-GB" sz="1200" b="0" i="0" u="none" strike="noStrike" kern="0" cap="none" spc="0" normalizeH="0" baseline="0" noProof="0" dirty="0">
                <a:ln>
                  <a:noFill/>
                </a:ln>
                <a:solidFill>
                  <a:srgbClr val="FFFFFF">
                    <a:lumMod val="50000"/>
                  </a:srgbClr>
                </a:solidFill>
                <a:effectLst/>
                <a:uLnTx/>
                <a:uFillTx/>
                <a:latin typeface="Calibri" panose="020F0502020204030204"/>
              </a:endParaRPr>
            </a:p>
            <a:p>
              <a:pPr marL="0" marR="0" lvl="0" indent="0" algn="ctr" defTabSz="4572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FFFFFF">
                      <a:lumMod val="50000"/>
                    </a:srgbClr>
                  </a:solidFill>
                  <a:effectLst/>
                  <a:uLnTx/>
                  <a:uFillTx/>
                  <a:latin typeface="Calibri" panose="020F0502020204030204"/>
                </a:rPr>
                <a:t>epithelium</a:t>
              </a:r>
            </a:p>
          </p:txBody>
        </p:sp>
        <p:grpSp>
          <p:nvGrpSpPr>
            <p:cNvPr id="387" name="Gruppieren 386"/>
            <p:cNvGrpSpPr/>
            <p:nvPr/>
          </p:nvGrpSpPr>
          <p:grpSpPr>
            <a:xfrm>
              <a:off x="635508" y="2135327"/>
              <a:ext cx="369332" cy="2388070"/>
              <a:chOff x="3174017" y="3398364"/>
              <a:chExt cx="369332" cy="2388070"/>
            </a:xfrm>
          </p:grpSpPr>
          <p:sp>
            <p:nvSpPr>
              <p:cNvPr id="388" name="Rechteck 387"/>
              <p:cNvSpPr/>
              <p:nvPr/>
            </p:nvSpPr>
            <p:spPr>
              <a:xfrm>
                <a:off x="3223682" y="3428999"/>
                <a:ext cx="270000" cy="2357435"/>
              </a:xfrm>
              <a:prstGeom prst="rect">
                <a:avLst/>
              </a:prstGeom>
              <a:solidFill>
                <a:srgbClr val="FFFFFF">
                  <a:lumMod val="95000"/>
                </a:srgbClr>
              </a:solidFill>
              <a:ln w="15875" cap="flat" cmpd="sng" algn="ctr">
                <a:noFill/>
                <a:prstDash val="solid"/>
              </a:ln>
              <a:effectLst/>
            </p:spPr>
            <p:txBody>
              <a:bodyPr rtlCol="0" anchor="ctr"/>
              <a:lstStyle/>
              <a:p>
                <a:pPr marL="0" marR="0" lvl="0" indent="0" algn="ctr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endParaRPr kumimoji="0" lang="en-GB" sz="1800" b="0" i="0" u="none" strike="noStrike" kern="0" cap="none" spc="0" normalizeH="0" baseline="0" noProof="0">
                  <a:ln>
                    <a:noFill/>
                  </a:ln>
                  <a:solidFill>
                    <a:srgbClr val="FFFFFF"/>
                  </a:solidFill>
                  <a:effectLst/>
                  <a:uLnTx/>
                  <a:uFillTx/>
                  <a:latin typeface="Calibri" panose="020F0502020204030204"/>
                  <a:ea typeface="+mn-ea"/>
                  <a:cs typeface="+mn-cs"/>
                </a:endParaRPr>
              </a:p>
            </p:txBody>
          </p:sp>
          <p:sp>
            <p:nvSpPr>
              <p:cNvPr id="389" name="Textfeld 388"/>
              <p:cNvSpPr txBox="1"/>
              <p:nvPr/>
            </p:nvSpPr>
            <p:spPr>
              <a:xfrm rot="16200000">
                <a:off x="2893074" y="3679307"/>
                <a:ext cx="931217" cy="3693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marL="0" marR="0" lvl="0" indent="0" defTabSz="914400" eaLnBrk="1" fontAlgn="auto" latinLnBrk="0" hangingPunct="1">
                  <a:lnSpc>
                    <a:spcPct val="100000"/>
                  </a:lnSpc>
                  <a:spcBef>
                    <a:spcPts val="0"/>
                  </a:spcBef>
                  <a:spcAft>
                    <a:spcPts val="0"/>
                  </a:spcAft>
                  <a:buClrTx/>
                  <a:buSzTx/>
                  <a:buFontTx/>
                  <a:buNone/>
                  <a:tabLst/>
                  <a:defRPr/>
                </a:pPr>
                <a:r>
                  <a:rPr kumimoji="0" lang="en-GB" sz="1800" b="0" i="0" u="none" strike="noStrike" kern="0" cap="none" spc="0" normalizeH="0" baseline="0" noProof="0" dirty="0">
                    <a:ln>
                      <a:noFill/>
                    </a:ln>
                    <a:solidFill>
                      <a:srgbClr val="2E2B21"/>
                    </a:solidFill>
                    <a:effectLst/>
                    <a:uLnTx/>
                    <a:uFillTx/>
                  </a:rPr>
                  <a:t>RWPE-1</a:t>
                </a:r>
              </a:p>
            </p:txBody>
          </p:sp>
        </p:grpSp>
        <p:sp>
          <p:nvSpPr>
            <p:cNvPr id="390" name="Freihandform 389"/>
            <p:cNvSpPr/>
            <p:nvPr/>
          </p:nvSpPr>
          <p:spPr>
            <a:xfrm>
              <a:off x="1321046" y="2998658"/>
              <a:ext cx="4301233" cy="1349921"/>
            </a:xfrm>
            <a:custGeom>
              <a:avLst/>
              <a:gdLst>
                <a:gd name="connsiteX0" fmla="*/ 0 w 4179313"/>
                <a:gd name="connsiteY0" fmla="*/ 1284648 h 1296293"/>
                <a:gd name="connsiteX1" fmla="*/ 381468 w 4179313"/>
                <a:gd name="connsiteY1" fmla="*/ 1172452 h 1296293"/>
                <a:gd name="connsiteX2" fmla="*/ 532933 w 4179313"/>
                <a:gd name="connsiteY2" fmla="*/ 712447 h 1296293"/>
                <a:gd name="connsiteX3" fmla="*/ 852692 w 4179313"/>
                <a:gd name="connsiteY3" fmla="*/ 936840 h 1296293"/>
                <a:gd name="connsiteX4" fmla="*/ 1099524 w 4179313"/>
                <a:gd name="connsiteY4" fmla="*/ 1245380 h 1296293"/>
                <a:gd name="connsiteX5" fmla="*/ 1929777 w 4179313"/>
                <a:gd name="connsiteY5" fmla="*/ 1250989 h 1296293"/>
                <a:gd name="connsiteX6" fmla="*/ 2277585 w 4179313"/>
                <a:gd name="connsiteY6" fmla="*/ 802204 h 1296293"/>
                <a:gd name="connsiteX7" fmla="*/ 2586125 w 4179313"/>
                <a:gd name="connsiteY7" fmla="*/ 1150013 h 1296293"/>
                <a:gd name="connsiteX8" fmla="*/ 2973202 w 4179313"/>
                <a:gd name="connsiteY8" fmla="*/ 409517 h 1296293"/>
                <a:gd name="connsiteX9" fmla="*/ 3298572 w 4179313"/>
                <a:gd name="connsiteY9" fmla="*/ 807814 h 1296293"/>
                <a:gd name="connsiteX10" fmla="*/ 3797845 w 4179313"/>
                <a:gd name="connsiteY10" fmla="*/ 56099 h 1296293"/>
                <a:gd name="connsiteX11" fmla="*/ 4022238 w 4179313"/>
                <a:gd name="connsiteY11" fmla="*/ 403907 h 1296293"/>
                <a:gd name="connsiteX12" fmla="*/ 4179313 w 4179313"/>
                <a:gd name="connsiteY12" fmla="*/ 0 h 1296293"/>
                <a:gd name="connsiteX0" fmla="*/ 0 w 4179313"/>
                <a:gd name="connsiteY0" fmla="*/ 1284648 h 1296293"/>
                <a:gd name="connsiteX1" fmla="*/ 381468 w 4179313"/>
                <a:gd name="connsiteY1" fmla="*/ 1172452 h 1296293"/>
                <a:gd name="connsiteX2" fmla="*/ 611471 w 4179313"/>
                <a:gd name="connsiteY2" fmla="*/ 560982 h 1296293"/>
                <a:gd name="connsiteX3" fmla="*/ 852692 w 4179313"/>
                <a:gd name="connsiteY3" fmla="*/ 936840 h 1296293"/>
                <a:gd name="connsiteX4" fmla="*/ 1099524 w 4179313"/>
                <a:gd name="connsiteY4" fmla="*/ 1245380 h 1296293"/>
                <a:gd name="connsiteX5" fmla="*/ 1929777 w 4179313"/>
                <a:gd name="connsiteY5" fmla="*/ 1250989 h 1296293"/>
                <a:gd name="connsiteX6" fmla="*/ 2277585 w 4179313"/>
                <a:gd name="connsiteY6" fmla="*/ 802204 h 1296293"/>
                <a:gd name="connsiteX7" fmla="*/ 2586125 w 4179313"/>
                <a:gd name="connsiteY7" fmla="*/ 1150013 h 1296293"/>
                <a:gd name="connsiteX8" fmla="*/ 2973202 w 4179313"/>
                <a:gd name="connsiteY8" fmla="*/ 409517 h 1296293"/>
                <a:gd name="connsiteX9" fmla="*/ 3298572 w 4179313"/>
                <a:gd name="connsiteY9" fmla="*/ 807814 h 1296293"/>
                <a:gd name="connsiteX10" fmla="*/ 3797845 w 4179313"/>
                <a:gd name="connsiteY10" fmla="*/ 56099 h 1296293"/>
                <a:gd name="connsiteX11" fmla="*/ 4022238 w 4179313"/>
                <a:gd name="connsiteY11" fmla="*/ 403907 h 1296293"/>
                <a:gd name="connsiteX12" fmla="*/ 4179313 w 4179313"/>
                <a:gd name="connsiteY12" fmla="*/ 0 h 1296293"/>
                <a:gd name="connsiteX0" fmla="*/ 0 w 4179313"/>
                <a:gd name="connsiteY0" fmla="*/ 1284648 h 1284648"/>
                <a:gd name="connsiteX1" fmla="*/ 381468 w 4179313"/>
                <a:gd name="connsiteY1" fmla="*/ 1172452 h 1284648"/>
                <a:gd name="connsiteX2" fmla="*/ 611471 w 4179313"/>
                <a:gd name="connsiteY2" fmla="*/ 560982 h 1284648"/>
                <a:gd name="connsiteX3" fmla="*/ 852692 w 4179313"/>
                <a:gd name="connsiteY3" fmla="*/ 936840 h 1284648"/>
                <a:gd name="connsiteX4" fmla="*/ 1099524 w 4179313"/>
                <a:gd name="connsiteY4" fmla="*/ 1245380 h 1284648"/>
                <a:gd name="connsiteX5" fmla="*/ 2019534 w 4179313"/>
                <a:gd name="connsiteY5" fmla="*/ 1211721 h 1284648"/>
                <a:gd name="connsiteX6" fmla="*/ 2277585 w 4179313"/>
                <a:gd name="connsiteY6" fmla="*/ 802204 h 1284648"/>
                <a:gd name="connsiteX7" fmla="*/ 2586125 w 4179313"/>
                <a:gd name="connsiteY7" fmla="*/ 1150013 h 1284648"/>
                <a:gd name="connsiteX8" fmla="*/ 2973202 w 4179313"/>
                <a:gd name="connsiteY8" fmla="*/ 409517 h 1284648"/>
                <a:gd name="connsiteX9" fmla="*/ 3298572 w 4179313"/>
                <a:gd name="connsiteY9" fmla="*/ 807814 h 1284648"/>
                <a:gd name="connsiteX10" fmla="*/ 3797845 w 4179313"/>
                <a:gd name="connsiteY10" fmla="*/ 56099 h 1284648"/>
                <a:gd name="connsiteX11" fmla="*/ 4022238 w 4179313"/>
                <a:gd name="connsiteY11" fmla="*/ 403907 h 1284648"/>
                <a:gd name="connsiteX12" fmla="*/ 4179313 w 4179313"/>
                <a:gd name="connsiteY12" fmla="*/ 0 h 1284648"/>
                <a:gd name="connsiteX0" fmla="*/ 0 w 4179313"/>
                <a:gd name="connsiteY0" fmla="*/ 1284648 h 1284648"/>
                <a:gd name="connsiteX1" fmla="*/ 381468 w 4179313"/>
                <a:gd name="connsiteY1" fmla="*/ 1172452 h 1284648"/>
                <a:gd name="connsiteX2" fmla="*/ 611471 w 4179313"/>
                <a:gd name="connsiteY2" fmla="*/ 560982 h 1284648"/>
                <a:gd name="connsiteX3" fmla="*/ 852692 w 4179313"/>
                <a:gd name="connsiteY3" fmla="*/ 936840 h 1284648"/>
                <a:gd name="connsiteX4" fmla="*/ 1099524 w 4179313"/>
                <a:gd name="connsiteY4" fmla="*/ 1245380 h 1284648"/>
                <a:gd name="connsiteX5" fmla="*/ 2019534 w 4179313"/>
                <a:gd name="connsiteY5" fmla="*/ 1211721 h 1284648"/>
                <a:gd name="connsiteX6" fmla="*/ 2277585 w 4179313"/>
                <a:gd name="connsiteY6" fmla="*/ 802204 h 1284648"/>
                <a:gd name="connsiteX7" fmla="*/ 2675882 w 4179313"/>
                <a:gd name="connsiteY7" fmla="*/ 1150013 h 1284648"/>
                <a:gd name="connsiteX8" fmla="*/ 2973202 w 4179313"/>
                <a:gd name="connsiteY8" fmla="*/ 409517 h 1284648"/>
                <a:gd name="connsiteX9" fmla="*/ 3298572 w 4179313"/>
                <a:gd name="connsiteY9" fmla="*/ 807814 h 1284648"/>
                <a:gd name="connsiteX10" fmla="*/ 3797845 w 4179313"/>
                <a:gd name="connsiteY10" fmla="*/ 56099 h 1284648"/>
                <a:gd name="connsiteX11" fmla="*/ 4022238 w 4179313"/>
                <a:gd name="connsiteY11" fmla="*/ 403907 h 1284648"/>
                <a:gd name="connsiteX12" fmla="*/ 4179313 w 4179313"/>
                <a:gd name="connsiteY12" fmla="*/ 0 h 1284648"/>
                <a:gd name="connsiteX0" fmla="*/ 0 w 4179313"/>
                <a:gd name="connsiteY0" fmla="*/ 1284648 h 1284648"/>
                <a:gd name="connsiteX1" fmla="*/ 381468 w 4179313"/>
                <a:gd name="connsiteY1" fmla="*/ 1172452 h 1284648"/>
                <a:gd name="connsiteX2" fmla="*/ 611471 w 4179313"/>
                <a:gd name="connsiteY2" fmla="*/ 560982 h 1284648"/>
                <a:gd name="connsiteX3" fmla="*/ 852692 w 4179313"/>
                <a:gd name="connsiteY3" fmla="*/ 936840 h 1284648"/>
                <a:gd name="connsiteX4" fmla="*/ 1099524 w 4179313"/>
                <a:gd name="connsiteY4" fmla="*/ 1245380 h 1284648"/>
                <a:gd name="connsiteX5" fmla="*/ 2019534 w 4179313"/>
                <a:gd name="connsiteY5" fmla="*/ 1211721 h 1284648"/>
                <a:gd name="connsiteX6" fmla="*/ 2277585 w 4179313"/>
                <a:gd name="connsiteY6" fmla="*/ 802204 h 1284648"/>
                <a:gd name="connsiteX7" fmla="*/ 2675882 w 4179313"/>
                <a:gd name="connsiteY7" fmla="*/ 1150013 h 1284648"/>
                <a:gd name="connsiteX8" fmla="*/ 2973202 w 4179313"/>
                <a:gd name="connsiteY8" fmla="*/ 409517 h 1284648"/>
                <a:gd name="connsiteX9" fmla="*/ 3461257 w 4179313"/>
                <a:gd name="connsiteY9" fmla="*/ 847083 h 1284648"/>
                <a:gd name="connsiteX10" fmla="*/ 3797845 w 4179313"/>
                <a:gd name="connsiteY10" fmla="*/ 56099 h 1284648"/>
                <a:gd name="connsiteX11" fmla="*/ 4022238 w 4179313"/>
                <a:gd name="connsiteY11" fmla="*/ 403907 h 1284648"/>
                <a:gd name="connsiteX12" fmla="*/ 4179313 w 4179313"/>
                <a:gd name="connsiteY12" fmla="*/ 0 h 1284648"/>
                <a:gd name="connsiteX0" fmla="*/ 0 w 4179313"/>
                <a:gd name="connsiteY0" fmla="*/ 1284648 h 1284648"/>
                <a:gd name="connsiteX1" fmla="*/ 381468 w 4179313"/>
                <a:gd name="connsiteY1" fmla="*/ 1172452 h 1284648"/>
                <a:gd name="connsiteX2" fmla="*/ 611471 w 4179313"/>
                <a:gd name="connsiteY2" fmla="*/ 560982 h 1284648"/>
                <a:gd name="connsiteX3" fmla="*/ 852692 w 4179313"/>
                <a:gd name="connsiteY3" fmla="*/ 936840 h 1284648"/>
                <a:gd name="connsiteX4" fmla="*/ 1099524 w 4179313"/>
                <a:gd name="connsiteY4" fmla="*/ 1245380 h 1284648"/>
                <a:gd name="connsiteX5" fmla="*/ 2019534 w 4179313"/>
                <a:gd name="connsiteY5" fmla="*/ 1211721 h 1284648"/>
                <a:gd name="connsiteX6" fmla="*/ 2277585 w 4179313"/>
                <a:gd name="connsiteY6" fmla="*/ 802204 h 1284648"/>
                <a:gd name="connsiteX7" fmla="*/ 2675882 w 4179313"/>
                <a:gd name="connsiteY7" fmla="*/ 1150013 h 1284648"/>
                <a:gd name="connsiteX8" fmla="*/ 2973202 w 4179313"/>
                <a:gd name="connsiteY8" fmla="*/ 409517 h 1284648"/>
                <a:gd name="connsiteX9" fmla="*/ 3461257 w 4179313"/>
                <a:gd name="connsiteY9" fmla="*/ 847083 h 1284648"/>
                <a:gd name="connsiteX10" fmla="*/ 3797845 w 4179313"/>
                <a:gd name="connsiteY10" fmla="*/ 56099 h 1284648"/>
                <a:gd name="connsiteX11" fmla="*/ 4022238 w 4179313"/>
                <a:gd name="connsiteY11" fmla="*/ 403907 h 1284648"/>
                <a:gd name="connsiteX12" fmla="*/ 4179313 w 4179313"/>
                <a:gd name="connsiteY12" fmla="*/ 0 h 1284648"/>
                <a:gd name="connsiteX0" fmla="*/ 0 w 4179313"/>
                <a:gd name="connsiteY0" fmla="*/ 1284648 h 1284648"/>
                <a:gd name="connsiteX1" fmla="*/ 381468 w 4179313"/>
                <a:gd name="connsiteY1" fmla="*/ 1172452 h 1284648"/>
                <a:gd name="connsiteX2" fmla="*/ 611471 w 4179313"/>
                <a:gd name="connsiteY2" fmla="*/ 560982 h 1284648"/>
                <a:gd name="connsiteX3" fmla="*/ 852692 w 4179313"/>
                <a:gd name="connsiteY3" fmla="*/ 936840 h 1284648"/>
                <a:gd name="connsiteX4" fmla="*/ 1099524 w 4179313"/>
                <a:gd name="connsiteY4" fmla="*/ 1245380 h 1284648"/>
                <a:gd name="connsiteX5" fmla="*/ 2019534 w 4179313"/>
                <a:gd name="connsiteY5" fmla="*/ 1211721 h 1284648"/>
                <a:gd name="connsiteX6" fmla="*/ 2277585 w 4179313"/>
                <a:gd name="connsiteY6" fmla="*/ 802204 h 1284648"/>
                <a:gd name="connsiteX7" fmla="*/ 2675882 w 4179313"/>
                <a:gd name="connsiteY7" fmla="*/ 1150013 h 1284648"/>
                <a:gd name="connsiteX8" fmla="*/ 2973202 w 4179313"/>
                <a:gd name="connsiteY8" fmla="*/ 409517 h 1284648"/>
                <a:gd name="connsiteX9" fmla="*/ 3461257 w 4179313"/>
                <a:gd name="connsiteY9" fmla="*/ 847083 h 1284648"/>
                <a:gd name="connsiteX10" fmla="*/ 3797845 w 4179313"/>
                <a:gd name="connsiteY10" fmla="*/ 56099 h 1284648"/>
                <a:gd name="connsiteX11" fmla="*/ 4095165 w 4179313"/>
                <a:gd name="connsiteY11" fmla="*/ 398297 h 1284648"/>
                <a:gd name="connsiteX12" fmla="*/ 4179313 w 4179313"/>
                <a:gd name="connsiteY12" fmla="*/ 0 h 1284648"/>
                <a:gd name="connsiteX0" fmla="*/ 0 w 4179313"/>
                <a:gd name="connsiteY0" fmla="*/ 1284648 h 1284648"/>
                <a:gd name="connsiteX1" fmla="*/ 381468 w 4179313"/>
                <a:gd name="connsiteY1" fmla="*/ 1172452 h 1284648"/>
                <a:gd name="connsiteX2" fmla="*/ 611471 w 4179313"/>
                <a:gd name="connsiteY2" fmla="*/ 560982 h 1284648"/>
                <a:gd name="connsiteX3" fmla="*/ 830253 w 4179313"/>
                <a:gd name="connsiteY3" fmla="*/ 942449 h 1284648"/>
                <a:gd name="connsiteX4" fmla="*/ 1099524 w 4179313"/>
                <a:gd name="connsiteY4" fmla="*/ 1245380 h 1284648"/>
                <a:gd name="connsiteX5" fmla="*/ 2019534 w 4179313"/>
                <a:gd name="connsiteY5" fmla="*/ 1211721 h 1284648"/>
                <a:gd name="connsiteX6" fmla="*/ 2277585 w 4179313"/>
                <a:gd name="connsiteY6" fmla="*/ 802204 h 1284648"/>
                <a:gd name="connsiteX7" fmla="*/ 2675882 w 4179313"/>
                <a:gd name="connsiteY7" fmla="*/ 1150013 h 1284648"/>
                <a:gd name="connsiteX8" fmla="*/ 2973202 w 4179313"/>
                <a:gd name="connsiteY8" fmla="*/ 409517 h 1284648"/>
                <a:gd name="connsiteX9" fmla="*/ 3461257 w 4179313"/>
                <a:gd name="connsiteY9" fmla="*/ 847083 h 1284648"/>
                <a:gd name="connsiteX10" fmla="*/ 3797845 w 4179313"/>
                <a:gd name="connsiteY10" fmla="*/ 56099 h 1284648"/>
                <a:gd name="connsiteX11" fmla="*/ 4095165 w 4179313"/>
                <a:gd name="connsiteY11" fmla="*/ 398297 h 1284648"/>
                <a:gd name="connsiteX12" fmla="*/ 4179313 w 4179313"/>
                <a:gd name="connsiteY12" fmla="*/ 0 h 1284648"/>
                <a:gd name="connsiteX0" fmla="*/ 0 w 4179313"/>
                <a:gd name="connsiteY0" fmla="*/ 1284648 h 1284648"/>
                <a:gd name="connsiteX1" fmla="*/ 381468 w 4179313"/>
                <a:gd name="connsiteY1" fmla="*/ 1172452 h 1284648"/>
                <a:gd name="connsiteX2" fmla="*/ 611471 w 4179313"/>
                <a:gd name="connsiteY2" fmla="*/ 560982 h 1284648"/>
                <a:gd name="connsiteX3" fmla="*/ 830253 w 4179313"/>
                <a:gd name="connsiteY3" fmla="*/ 942449 h 1284648"/>
                <a:gd name="connsiteX4" fmla="*/ 1099524 w 4179313"/>
                <a:gd name="connsiteY4" fmla="*/ 1245380 h 1284648"/>
                <a:gd name="connsiteX5" fmla="*/ 2019534 w 4179313"/>
                <a:gd name="connsiteY5" fmla="*/ 1211721 h 1284648"/>
                <a:gd name="connsiteX6" fmla="*/ 2277585 w 4179313"/>
                <a:gd name="connsiteY6" fmla="*/ 802204 h 1284648"/>
                <a:gd name="connsiteX7" fmla="*/ 2675882 w 4179313"/>
                <a:gd name="connsiteY7" fmla="*/ 1150013 h 1284648"/>
                <a:gd name="connsiteX8" fmla="*/ 2973202 w 4179313"/>
                <a:gd name="connsiteY8" fmla="*/ 409517 h 1284648"/>
                <a:gd name="connsiteX9" fmla="*/ 3461257 w 4179313"/>
                <a:gd name="connsiteY9" fmla="*/ 847083 h 1284648"/>
                <a:gd name="connsiteX10" fmla="*/ 3797845 w 4179313"/>
                <a:gd name="connsiteY10" fmla="*/ 56099 h 1284648"/>
                <a:gd name="connsiteX11" fmla="*/ 4095165 w 4179313"/>
                <a:gd name="connsiteY11" fmla="*/ 398297 h 1284648"/>
                <a:gd name="connsiteX12" fmla="*/ 4179313 w 4179313"/>
                <a:gd name="connsiteY12" fmla="*/ 0 h 1284648"/>
                <a:gd name="connsiteX0" fmla="*/ 0 w 4362193"/>
                <a:gd name="connsiteY0" fmla="*/ 1293357 h 1293357"/>
                <a:gd name="connsiteX1" fmla="*/ 381468 w 4362193"/>
                <a:gd name="connsiteY1" fmla="*/ 1181161 h 1293357"/>
                <a:gd name="connsiteX2" fmla="*/ 611471 w 4362193"/>
                <a:gd name="connsiteY2" fmla="*/ 569691 h 1293357"/>
                <a:gd name="connsiteX3" fmla="*/ 830253 w 4362193"/>
                <a:gd name="connsiteY3" fmla="*/ 951158 h 1293357"/>
                <a:gd name="connsiteX4" fmla="*/ 1099524 w 4362193"/>
                <a:gd name="connsiteY4" fmla="*/ 1254089 h 1293357"/>
                <a:gd name="connsiteX5" fmla="*/ 2019534 w 4362193"/>
                <a:gd name="connsiteY5" fmla="*/ 1220430 h 1293357"/>
                <a:gd name="connsiteX6" fmla="*/ 2277585 w 4362193"/>
                <a:gd name="connsiteY6" fmla="*/ 810913 h 1293357"/>
                <a:gd name="connsiteX7" fmla="*/ 2675882 w 4362193"/>
                <a:gd name="connsiteY7" fmla="*/ 1158722 h 1293357"/>
                <a:gd name="connsiteX8" fmla="*/ 2973202 w 4362193"/>
                <a:gd name="connsiteY8" fmla="*/ 418226 h 1293357"/>
                <a:gd name="connsiteX9" fmla="*/ 3461257 w 4362193"/>
                <a:gd name="connsiteY9" fmla="*/ 855792 h 1293357"/>
                <a:gd name="connsiteX10" fmla="*/ 3797845 w 4362193"/>
                <a:gd name="connsiteY10" fmla="*/ 64808 h 1293357"/>
                <a:gd name="connsiteX11" fmla="*/ 4095165 w 4362193"/>
                <a:gd name="connsiteY11" fmla="*/ 407006 h 1293357"/>
                <a:gd name="connsiteX12" fmla="*/ 4362193 w 4362193"/>
                <a:gd name="connsiteY12" fmla="*/ 0 h 1293357"/>
                <a:gd name="connsiteX0" fmla="*/ 0 w 4362193"/>
                <a:gd name="connsiteY0" fmla="*/ 1293357 h 1293357"/>
                <a:gd name="connsiteX1" fmla="*/ 381468 w 4362193"/>
                <a:gd name="connsiteY1" fmla="*/ 1181161 h 1293357"/>
                <a:gd name="connsiteX2" fmla="*/ 611471 w 4362193"/>
                <a:gd name="connsiteY2" fmla="*/ 569691 h 1293357"/>
                <a:gd name="connsiteX3" fmla="*/ 830253 w 4362193"/>
                <a:gd name="connsiteY3" fmla="*/ 951158 h 1293357"/>
                <a:gd name="connsiteX4" fmla="*/ 1099524 w 4362193"/>
                <a:gd name="connsiteY4" fmla="*/ 1254089 h 1293357"/>
                <a:gd name="connsiteX5" fmla="*/ 2019534 w 4362193"/>
                <a:gd name="connsiteY5" fmla="*/ 1220430 h 1293357"/>
                <a:gd name="connsiteX6" fmla="*/ 2277585 w 4362193"/>
                <a:gd name="connsiteY6" fmla="*/ 810913 h 1293357"/>
                <a:gd name="connsiteX7" fmla="*/ 2675882 w 4362193"/>
                <a:gd name="connsiteY7" fmla="*/ 1158722 h 1293357"/>
                <a:gd name="connsiteX8" fmla="*/ 2973202 w 4362193"/>
                <a:gd name="connsiteY8" fmla="*/ 418226 h 1293357"/>
                <a:gd name="connsiteX9" fmla="*/ 3461257 w 4362193"/>
                <a:gd name="connsiteY9" fmla="*/ 855792 h 1293357"/>
                <a:gd name="connsiteX10" fmla="*/ 3797845 w 4362193"/>
                <a:gd name="connsiteY10" fmla="*/ 64808 h 1293357"/>
                <a:gd name="connsiteX11" fmla="*/ 4251919 w 4362193"/>
                <a:gd name="connsiteY11" fmla="*/ 415715 h 1293357"/>
                <a:gd name="connsiteX12" fmla="*/ 4362193 w 4362193"/>
                <a:gd name="connsiteY12" fmla="*/ 0 h 1293357"/>
                <a:gd name="connsiteX0" fmla="*/ 0 w 4362193"/>
                <a:gd name="connsiteY0" fmla="*/ 1293357 h 1293357"/>
                <a:gd name="connsiteX1" fmla="*/ 381468 w 4362193"/>
                <a:gd name="connsiteY1" fmla="*/ 1181161 h 1293357"/>
                <a:gd name="connsiteX2" fmla="*/ 611471 w 4362193"/>
                <a:gd name="connsiteY2" fmla="*/ 569691 h 1293357"/>
                <a:gd name="connsiteX3" fmla="*/ 830253 w 4362193"/>
                <a:gd name="connsiteY3" fmla="*/ 951158 h 1293357"/>
                <a:gd name="connsiteX4" fmla="*/ 1099524 w 4362193"/>
                <a:gd name="connsiteY4" fmla="*/ 1254089 h 1293357"/>
                <a:gd name="connsiteX5" fmla="*/ 2019534 w 4362193"/>
                <a:gd name="connsiteY5" fmla="*/ 1220430 h 1293357"/>
                <a:gd name="connsiteX6" fmla="*/ 2277585 w 4362193"/>
                <a:gd name="connsiteY6" fmla="*/ 810913 h 1293357"/>
                <a:gd name="connsiteX7" fmla="*/ 2675882 w 4362193"/>
                <a:gd name="connsiteY7" fmla="*/ 1158722 h 1293357"/>
                <a:gd name="connsiteX8" fmla="*/ 2973202 w 4362193"/>
                <a:gd name="connsiteY8" fmla="*/ 418226 h 1293357"/>
                <a:gd name="connsiteX9" fmla="*/ 3461257 w 4362193"/>
                <a:gd name="connsiteY9" fmla="*/ 855792 h 1293357"/>
                <a:gd name="connsiteX10" fmla="*/ 3980725 w 4362193"/>
                <a:gd name="connsiteY10" fmla="*/ 64808 h 1293357"/>
                <a:gd name="connsiteX11" fmla="*/ 4251919 w 4362193"/>
                <a:gd name="connsiteY11" fmla="*/ 415715 h 1293357"/>
                <a:gd name="connsiteX12" fmla="*/ 4362193 w 4362193"/>
                <a:gd name="connsiteY12" fmla="*/ 0 h 1293357"/>
                <a:gd name="connsiteX0" fmla="*/ 0 w 4362193"/>
                <a:gd name="connsiteY0" fmla="*/ 1293357 h 1293357"/>
                <a:gd name="connsiteX1" fmla="*/ 381468 w 4362193"/>
                <a:gd name="connsiteY1" fmla="*/ 1181161 h 1293357"/>
                <a:gd name="connsiteX2" fmla="*/ 611471 w 4362193"/>
                <a:gd name="connsiteY2" fmla="*/ 569691 h 1293357"/>
                <a:gd name="connsiteX3" fmla="*/ 830253 w 4362193"/>
                <a:gd name="connsiteY3" fmla="*/ 951158 h 1293357"/>
                <a:gd name="connsiteX4" fmla="*/ 1099524 w 4362193"/>
                <a:gd name="connsiteY4" fmla="*/ 1254089 h 1293357"/>
                <a:gd name="connsiteX5" fmla="*/ 2019534 w 4362193"/>
                <a:gd name="connsiteY5" fmla="*/ 1220430 h 1293357"/>
                <a:gd name="connsiteX6" fmla="*/ 2277585 w 4362193"/>
                <a:gd name="connsiteY6" fmla="*/ 810913 h 1293357"/>
                <a:gd name="connsiteX7" fmla="*/ 2675882 w 4362193"/>
                <a:gd name="connsiteY7" fmla="*/ 1158722 h 1293357"/>
                <a:gd name="connsiteX8" fmla="*/ 2973202 w 4362193"/>
                <a:gd name="connsiteY8" fmla="*/ 418226 h 1293357"/>
                <a:gd name="connsiteX9" fmla="*/ 3522217 w 4362193"/>
                <a:gd name="connsiteY9" fmla="*/ 812249 h 1293357"/>
                <a:gd name="connsiteX10" fmla="*/ 3980725 w 4362193"/>
                <a:gd name="connsiteY10" fmla="*/ 64808 h 1293357"/>
                <a:gd name="connsiteX11" fmla="*/ 4251919 w 4362193"/>
                <a:gd name="connsiteY11" fmla="*/ 415715 h 1293357"/>
                <a:gd name="connsiteX12" fmla="*/ 4362193 w 4362193"/>
                <a:gd name="connsiteY12" fmla="*/ 0 h 1293357"/>
                <a:gd name="connsiteX0" fmla="*/ 0 w 4362193"/>
                <a:gd name="connsiteY0" fmla="*/ 1293357 h 1293357"/>
                <a:gd name="connsiteX1" fmla="*/ 381468 w 4362193"/>
                <a:gd name="connsiteY1" fmla="*/ 1181161 h 1293357"/>
                <a:gd name="connsiteX2" fmla="*/ 611471 w 4362193"/>
                <a:gd name="connsiteY2" fmla="*/ 569691 h 1293357"/>
                <a:gd name="connsiteX3" fmla="*/ 830253 w 4362193"/>
                <a:gd name="connsiteY3" fmla="*/ 951158 h 1293357"/>
                <a:gd name="connsiteX4" fmla="*/ 1099524 w 4362193"/>
                <a:gd name="connsiteY4" fmla="*/ 1254089 h 1293357"/>
                <a:gd name="connsiteX5" fmla="*/ 2019534 w 4362193"/>
                <a:gd name="connsiteY5" fmla="*/ 1220430 h 1293357"/>
                <a:gd name="connsiteX6" fmla="*/ 2277585 w 4362193"/>
                <a:gd name="connsiteY6" fmla="*/ 810913 h 1293357"/>
                <a:gd name="connsiteX7" fmla="*/ 2675882 w 4362193"/>
                <a:gd name="connsiteY7" fmla="*/ 1158722 h 1293357"/>
                <a:gd name="connsiteX8" fmla="*/ 3103831 w 4362193"/>
                <a:gd name="connsiteY8" fmla="*/ 418226 h 1293357"/>
                <a:gd name="connsiteX9" fmla="*/ 3522217 w 4362193"/>
                <a:gd name="connsiteY9" fmla="*/ 812249 h 1293357"/>
                <a:gd name="connsiteX10" fmla="*/ 3980725 w 4362193"/>
                <a:gd name="connsiteY10" fmla="*/ 64808 h 1293357"/>
                <a:gd name="connsiteX11" fmla="*/ 4251919 w 4362193"/>
                <a:gd name="connsiteY11" fmla="*/ 415715 h 1293357"/>
                <a:gd name="connsiteX12" fmla="*/ 4362193 w 4362193"/>
                <a:gd name="connsiteY12" fmla="*/ 0 h 1293357"/>
                <a:gd name="connsiteX0" fmla="*/ 0 w 4362193"/>
                <a:gd name="connsiteY0" fmla="*/ 1293357 h 1293357"/>
                <a:gd name="connsiteX1" fmla="*/ 381468 w 4362193"/>
                <a:gd name="connsiteY1" fmla="*/ 1181161 h 1293357"/>
                <a:gd name="connsiteX2" fmla="*/ 611471 w 4362193"/>
                <a:gd name="connsiteY2" fmla="*/ 569691 h 1293357"/>
                <a:gd name="connsiteX3" fmla="*/ 830253 w 4362193"/>
                <a:gd name="connsiteY3" fmla="*/ 951158 h 1293357"/>
                <a:gd name="connsiteX4" fmla="*/ 1099524 w 4362193"/>
                <a:gd name="connsiteY4" fmla="*/ 1254089 h 1293357"/>
                <a:gd name="connsiteX5" fmla="*/ 2019534 w 4362193"/>
                <a:gd name="connsiteY5" fmla="*/ 1220430 h 1293357"/>
                <a:gd name="connsiteX6" fmla="*/ 2277585 w 4362193"/>
                <a:gd name="connsiteY6" fmla="*/ 810913 h 1293357"/>
                <a:gd name="connsiteX7" fmla="*/ 2675882 w 4362193"/>
                <a:gd name="connsiteY7" fmla="*/ 1158722 h 1293357"/>
                <a:gd name="connsiteX8" fmla="*/ 3103831 w 4362193"/>
                <a:gd name="connsiteY8" fmla="*/ 418226 h 1293357"/>
                <a:gd name="connsiteX9" fmla="*/ 3522217 w 4362193"/>
                <a:gd name="connsiteY9" fmla="*/ 812249 h 1293357"/>
                <a:gd name="connsiteX10" fmla="*/ 3980725 w 4362193"/>
                <a:gd name="connsiteY10" fmla="*/ 64808 h 1293357"/>
                <a:gd name="connsiteX11" fmla="*/ 4182251 w 4362193"/>
                <a:gd name="connsiteY11" fmla="*/ 328630 h 1293357"/>
                <a:gd name="connsiteX12" fmla="*/ 4362193 w 4362193"/>
                <a:gd name="connsiteY12" fmla="*/ 0 h 1293357"/>
                <a:gd name="connsiteX0" fmla="*/ 0 w 4301233"/>
                <a:gd name="connsiteY0" fmla="*/ 1336900 h 1336900"/>
                <a:gd name="connsiteX1" fmla="*/ 381468 w 4301233"/>
                <a:gd name="connsiteY1" fmla="*/ 1224704 h 1336900"/>
                <a:gd name="connsiteX2" fmla="*/ 611471 w 4301233"/>
                <a:gd name="connsiteY2" fmla="*/ 613234 h 1336900"/>
                <a:gd name="connsiteX3" fmla="*/ 830253 w 4301233"/>
                <a:gd name="connsiteY3" fmla="*/ 994701 h 1336900"/>
                <a:gd name="connsiteX4" fmla="*/ 1099524 w 4301233"/>
                <a:gd name="connsiteY4" fmla="*/ 1297632 h 1336900"/>
                <a:gd name="connsiteX5" fmla="*/ 2019534 w 4301233"/>
                <a:gd name="connsiteY5" fmla="*/ 1263973 h 1336900"/>
                <a:gd name="connsiteX6" fmla="*/ 2277585 w 4301233"/>
                <a:gd name="connsiteY6" fmla="*/ 854456 h 1336900"/>
                <a:gd name="connsiteX7" fmla="*/ 2675882 w 4301233"/>
                <a:gd name="connsiteY7" fmla="*/ 1202265 h 1336900"/>
                <a:gd name="connsiteX8" fmla="*/ 3103831 w 4301233"/>
                <a:gd name="connsiteY8" fmla="*/ 461769 h 1336900"/>
                <a:gd name="connsiteX9" fmla="*/ 3522217 w 4301233"/>
                <a:gd name="connsiteY9" fmla="*/ 855792 h 1336900"/>
                <a:gd name="connsiteX10" fmla="*/ 3980725 w 4301233"/>
                <a:gd name="connsiteY10" fmla="*/ 108351 h 1336900"/>
                <a:gd name="connsiteX11" fmla="*/ 4182251 w 4301233"/>
                <a:gd name="connsiteY11" fmla="*/ 372173 h 1336900"/>
                <a:gd name="connsiteX12" fmla="*/ 4301233 w 4301233"/>
                <a:gd name="connsiteY12" fmla="*/ 0 h 1336900"/>
                <a:gd name="connsiteX0" fmla="*/ 0 w 4301233"/>
                <a:gd name="connsiteY0" fmla="*/ 1336900 h 1336900"/>
                <a:gd name="connsiteX1" fmla="*/ 381468 w 4301233"/>
                <a:gd name="connsiteY1" fmla="*/ 1224704 h 1336900"/>
                <a:gd name="connsiteX2" fmla="*/ 611471 w 4301233"/>
                <a:gd name="connsiteY2" fmla="*/ 613234 h 1336900"/>
                <a:gd name="connsiteX3" fmla="*/ 830253 w 4301233"/>
                <a:gd name="connsiteY3" fmla="*/ 994701 h 1336900"/>
                <a:gd name="connsiteX4" fmla="*/ 1099524 w 4301233"/>
                <a:gd name="connsiteY4" fmla="*/ 1297632 h 1336900"/>
                <a:gd name="connsiteX5" fmla="*/ 2019534 w 4301233"/>
                <a:gd name="connsiteY5" fmla="*/ 1263973 h 1336900"/>
                <a:gd name="connsiteX6" fmla="*/ 2333683 w 4301233"/>
                <a:gd name="connsiteY6" fmla="*/ 860066 h 1336900"/>
                <a:gd name="connsiteX7" fmla="*/ 2675882 w 4301233"/>
                <a:gd name="connsiteY7" fmla="*/ 1202265 h 1336900"/>
                <a:gd name="connsiteX8" fmla="*/ 3103831 w 4301233"/>
                <a:gd name="connsiteY8" fmla="*/ 461769 h 1336900"/>
                <a:gd name="connsiteX9" fmla="*/ 3522217 w 4301233"/>
                <a:gd name="connsiteY9" fmla="*/ 855792 h 1336900"/>
                <a:gd name="connsiteX10" fmla="*/ 3980725 w 4301233"/>
                <a:gd name="connsiteY10" fmla="*/ 108351 h 1336900"/>
                <a:gd name="connsiteX11" fmla="*/ 4182251 w 4301233"/>
                <a:gd name="connsiteY11" fmla="*/ 372173 h 1336900"/>
                <a:gd name="connsiteX12" fmla="*/ 4301233 w 4301233"/>
                <a:gd name="connsiteY12" fmla="*/ 0 h 1336900"/>
                <a:gd name="connsiteX0" fmla="*/ 0 w 4301233"/>
                <a:gd name="connsiteY0" fmla="*/ 1336900 h 1336900"/>
                <a:gd name="connsiteX1" fmla="*/ 381468 w 4301233"/>
                <a:gd name="connsiteY1" fmla="*/ 1224704 h 1336900"/>
                <a:gd name="connsiteX2" fmla="*/ 611471 w 4301233"/>
                <a:gd name="connsiteY2" fmla="*/ 613234 h 1336900"/>
                <a:gd name="connsiteX3" fmla="*/ 830253 w 4301233"/>
                <a:gd name="connsiteY3" fmla="*/ 994701 h 1336900"/>
                <a:gd name="connsiteX4" fmla="*/ 1099524 w 4301233"/>
                <a:gd name="connsiteY4" fmla="*/ 1297632 h 1336900"/>
                <a:gd name="connsiteX5" fmla="*/ 2019534 w 4301233"/>
                <a:gd name="connsiteY5" fmla="*/ 1263973 h 1336900"/>
                <a:gd name="connsiteX6" fmla="*/ 2333683 w 4301233"/>
                <a:gd name="connsiteY6" fmla="*/ 860066 h 1336900"/>
                <a:gd name="connsiteX7" fmla="*/ 2675882 w 4301233"/>
                <a:gd name="connsiteY7" fmla="*/ 1202265 h 1336900"/>
                <a:gd name="connsiteX8" fmla="*/ 3103831 w 4301233"/>
                <a:gd name="connsiteY8" fmla="*/ 461769 h 1336900"/>
                <a:gd name="connsiteX9" fmla="*/ 3522217 w 4301233"/>
                <a:gd name="connsiteY9" fmla="*/ 855792 h 1336900"/>
                <a:gd name="connsiteX10" fmla="*/ 3947066 w 4301233"/>
                <a:gd name="connsiteY10" fmla="*/ 108351 h 1336900"/>
                <a:gd name="connsiteX11" fmla="*/ 4182251 w 4301233"/>
                <a:gd name="connsiteY11" fmla="*/ 372173 h 1336900"/>
                <a:gd name="connsiteX12" fmla="*/ 4301233 w 4301233"/>
                <a:gd name="connsiteY12" fmla="*/ 0 h 1336900"/>
                <a:gd name="connsiteX0" fmla="*/ 0 w 4301233"/>
                <a:gd name="connsiteY0" fmla="*/ 1336900 h 1336900"/>
                <a:gd name="connsiteX1" fmla="*/ 381468 w 4301233"/>
                <a:gd name="connsiteY1" fmla="*/ 1224704 h 1336900"/>
                <a:gd name="connsiteX2" fmla="*/ 611471 w 4301233"/>
                <a:gd name="connsiteY2" fmla="*/ 613234 h 1336900"/>
                <a:gd name="connsiteX3" fmla="*/ 830253 w 4301233"/>
                <a:gd name="connsiteY3" fmla="*/ 994701 h 1336900"/>
                <a:gd name="connsiteX4" fmla="*/ 1099524 w 4301233"/>
                <a:gd name="connsiteY4" fmla="*/ 1297632 h 1336900"/>
                <a:gd name="connsiteX5" fmla="*/ 2114901 w 4301233"/>
                <a:gd name="connsiteY5" fmla="*/ 1263973 h 1336900"/>
                <a:gd name="connsiteX6" fmla="*/ 2333683 w 4301233"/>
                <a:gd name="connsiteY6" fmla="*/ 860066 h 1336900"/>
                <a:gd name="connsiteX7" fmla="*/ 2675882 w 4301233"/>
                <a:gd name="connsiteY7" fmla="*/ 1202265 h 1336900"/>
                <a:gd name="connsiteX8" fmla="*/ 3103831 w 4301233"/>
                <a:gd name="connsiteY8" fmla="*/ 461769 h 1336900"/>
                <a:gd name="connsiteX9" fmla="*/ 3522217 w 4301233"/>
                <a:gd name="connsiteY9" fmla="*/ 855792 h 1336900"/>
                <a:gd name="connsiteX10" fmla="*/ 3947066 w 4301233"/>
                <a:gd name="connsiteY10" fmla="*/ 108351 h 1336900"/>
                <a:gd name="connsiteX11" fmla="*/ 4182251 w 4301233"/>
                <a:gd name="connsiteY11" fmla="*/ 372173 h 1336900"/>
                <a:gd name="connsiteX12" fmla="*/ 4301233 w 4301233"/>
                <a:gd name="connsiteY12" fmla="*/ 0 h 1336900"/>
                <a:gd name="connsiteX0" fmla="*/ 0 w 4301233"/>
                <a:gd name="connsiteY0" fmla="*/ 1336900 h 1336900"/>
                <a:gd name="connsiteX1" fmla="*/ 381468 w 4301233"/>
                <a:gd name="connsiteY1" fmla="*/ 1224704 h 1336900"/>
                <a:gd name="connsiteX2" fmla="*/ 611471 w 4301233"/>
                <a:gd name="connsiteY2" fmla="*/ 613234 h 1336900"/>
                <a:gd name="connsiteX3" fmla="*/ 830253 w 4301233"/>
                <a:gd name="connsiteY3" fmla="*/ 994701 h 1336900"/>
                <a:gd name="connsiteX4" fmla="*/ 1099524 w 4301233"/>
                <a:gd name="connsiteY4" fmla="*/ 1297632 h 1336900"/>
                <a:gd name="connsiteX5" fmla="*/ 2081242 w 4301233"/>
                <a:gd name="connsiteY5" fmla="*/ 1258363 h 1336900"/>
                <a:gd name="connsiteX6" fmla="*/ 2333683 w 4301233"/>
                <a:gd name="connsiteY6" fmla="*/ 860066 h 1336900"/>
                <a:gd name="connsiteX7" fmla="*/ 2675882 w 4301233"/>
                <a:gd name="connsiteY7" fmla="*/ 1202265 h 1336900"/>
                <a:gd name="connsiteX8" fmla="*/ 3103831 w 4301233"/>
                <a:gd name="connsiteY8" fmla="*/ 461769 h 1336900"/>
                <a:gd name="connsiteX9" fmla="*/ 3522217 w 4301233"/>
                <a:gd name="connsiteY9" fmla="*/ 855792 h 1336900"/>
                <a:gd name="connsiteX10" fmla="*/ 3947066 w 4301233"/>
                <a:gd name="connsiteY10" fmla="*/ 108351 h 1336900"/>
                <a:gd name="connsiteX11" fmla="*/ 4182251 w 4301233"/>
                <a:gd name="connsiteY11" fmla="*/ 372173 h 1336900"/>
                <a:gd name="connsiteX12" fmla="*/ 4301233 w 4301233"/>
                <a:gd name="connsiteY12" fmla="*/ 0 h 1336900"/>
                <a:gd name="connsiteX0" fmla="*/ 0 w 4301233"/>
                <a:gd name="connsiteY0" fmla="*/ 1336900 h 1340869"/>
                <a:gd name="connsiteX1" fmla="*/ 381468 w 4301233"/>
                <a:gd name="connsiteY1" fmla="*/ 1224704 h 1340869"/>
                <a:gd name="connsiteX2" fmla="*/ 611471 w 4301233"/>
                <a:gd name="connsiteY2" fmla="*/ 613234 h 1340869"/>
                <a:gd name="connsiteX3" fmla="*/ 830253 w 4301233"/>
                <a:gd name="connsiteY3" fmla="*/ 994701 h 1340869"/>
                <a:gd name="connsiteX4" fmla="*/ 1099524 w 4301233"/>
                <a:gd name="connsiteY4" fmla="*/ 1297632 h 1340869"/>
                <a:gd name="connsiteX5" fmla="*/ 2058802 w 4301233"/>
                <a:gd name="connsiteY5" fmla="*/ 1292022 h 1340869"/>
                <a:gd name="connsiteX6" fmla="*/ 2333683 w 4301233"/>
                <a:gd name="connsiteY6" fmla="*/ 860066 h 1340869"/>
                <a:gd name="connsiteX7" fmla="*/ 2675882 w 4301233"/>
                <a:gd name="connsiteY7" fmla="*/ 1202265 h 1340869"/>
                <a:gd name="connsiteX8" fmla="*/ 3103831 w 4301233"/>
                <a:gd name="connsiteY8" fmla="*/ 461769 h 1340869"/>
                <a:gd name="connsiteX9" fmla="*/ 3522217 w 4301233"/>
                <a:gd name="connsiteY9" fmla="*/ 855792 h 1340869"/>
                <a:gd name="connsiteX10" fmla="*/ 3947066 w 4301233"/>
                <a:gd name="connsiteY10" fmla="*/ 108351 h 1340869"/>
                <a:gd name="connsiteX11" fmla="*/ 4182251 w 4301233"/>
                <a:gd name="connsiteY11" fmla="*/ 372173 h 1340869"/>
                <a:gd name="connsiteX12" fmla="*/ 4301233 w 4301233"/>
                <a:gd name="connsiteY12" fmla="*/ 0 h 1340869"/>
                <a:gd name="connsiteX0" fmla="*/ 0 w 4301233"/>
                <a:gd name="connsiteY0" fmla="*/ 1336900 h 1349921"/>
                <a:gd name="connsiteX1" fmla="*/ 381468 w 4301233"/>
                <a:gd name="connsiteY1" fmla="*/ 1224704 h 1349921"/>
                <a:gd name="connsiteX2" fmla="*/ 611471 w 4301233"/>
                <a:gd name="connsiteY2" fmla="*/ 613234 h 1349921"/>
                <a:gd name="connsiteX3" fmla="*/ 830253 w 4301233"/>
                <a:gd name="connsiteY3" fmla="*/ 994701 h 1349921"/>
                <a:gd name="connsiteX4" fmla="*/ 1099524 w 4301233"/>
                <a:gd name="connsiteY4" fmla="*/ 1297632 h 1349921"/>
                <a:gd name="connsiteX5" fmla="*/ 2058802 w 4301233"/>
                <a:gd name="connsiteY5" fmla="*/ 1292022 h 1349921"/>
                <a:gd name="connsiteX6" fmla="*/ 2333683 w 4301233"/>
                <a:gd name="connsiteY6" fmla="*/ 860066 h 1349921"/>
                <a:gd name="connsiteX7" fmla="*/ 2675882 w 4301233"/>
                <a:gd name="connsiteY7" fmla="*/ 1202265 h 1349921"/>
                <a:gd name="connsiteX8" fmla="*/ 3103831 w 4301233"/>
                <a:gd name="connsiteY8" fmla="*/ 461769 h 1349921"/>
                <a:gd name="connsiteX9" fmla="*/ 3522217 w 4301233"/>
                <a:gd name="connsiteY9" fmla="*/ 855792 h 1349921"/>
                <a:gd name="connsiteX10" fmla="*/ 3947066 w 4301233"/>
                <a:gd name="connsiteY10" fmla="*/ 108351 h 1349921"/>
                <a:gd name="connsiteX11" fmla="*/ 4182251 w 4301233"/>
                <a:gd name="connsiteY11" fmla="*/ 372173 h 1349921"/>
                <a:gd name="connsiteX12" fmla="*/ 4301233 w 4301233"/>
                <a:gd name="connsiteY12" fmla="*/ 0 h 1349921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</a:cxnLst>
              <a:rect l="l" t="t" r="r" b="b"/>
              <a:pathLst>
                <a:path w="4301233" h="1349921">
                  <a:moveTo>
                    <a:pt x="0" y="1336900"/>
                  </a:moveTo>
                  <a:cubicBezTo>
                    <a:pt x="146323" y="1328485"/>
                    <a:pt x="279556" y="1345315"/>
                    <a:pt x="381468" y="1224704"/>
                  </a:cubicBezTo>
                  <a:cubicBezTo>
                    <a:pt x="483380" y="1104093"/>
                    <a:pt x="536674" y="651568"/>
                    <a:pt x="611471" y="613234"/>
                  </a:cubicBezTo>
                  <a:cubicBezTo>
                    <a:pt x="686269" y="574900"/>
                    <a:pt x="771350" y="880635"/>
                    <a:pt x="830253" y="994701"/>
                  </a:cubicBezTo>
                  <a:cubicBezTo>
                    <a:pt x="889156" y="1108767"/>
                    <a:pt x="894766" y="1248079"/>
                    <a:pt x="1099524" y="1297632"/>
                  </a:cubicBezTo>
                  <a:cubicBezTo>
                    <a:pt x="1304282" y="1347185"/>
                    <a:pt x="1858719" y="1387390"/>
                    <a:pt x="2058802" y="1292022"/>
                  </a:cubicBezTo>
                  <a:cubicBezTo>
                    <a:pt x="2258885" y="1196654"/>
                    <a:pt x="2230836" y="875025"/>
                    <a:pt x="2333683" y="860066"/>
                  </a:cubicBezTo>
                  <a:cubicBezTo>
                    <a:pt x="2436530" y="845107"/>
                    <a:pt x="2547524" y="1268648"/>
                    <a:pt x="2675882" y="1202265"/>
                  </a:cubicBezTo>
                  <a:cubicBezTo>
                    <a:pt x="2804240" y="1135882"/>
                    <a:pt x="2962775" y="519514"/>
                    <a:pt x="3103831" y="461769"/>
                  </a:cubicBezTo>
                  <a:cubicBezTo>
                    <a:pt x="3244887" y="404024"/>
                    <a:pt x="3381678" y="914695"/>
                    <a:pt x="3522217" y="855792"/>
                  </a:cubicBezTo>
                  <a:cubicBezTo>
                    <a:pt x="3662756" y="796889"/>
                    <a:pt x="3837060" y="188954"/>
                    <a:pt x="3947066" y="108351"/>
                  </a:cubicBezTo>
                  <a:cubicBezTo>
                    <a:pt x="4057072" y="27748"/>
                    <a:pt x="4118673" y="381523"/>
                    <a:pt x="4182251" y="372173"/>
                  </a:cubicBezTo>
                  <a:cubicBezTo>
                    <a:pt x="4245829" y="362823"/>
                    <a:pt x="4280664" y="69188"/>
                    <a:pt x="4301233" y="0"/>
                  </a:cubicBezTo>
                </a:path>
              </a:pathLst>
            </a:custGeom>
            <a:noFill/>
            <a:ln w="28575" cap="flat" cmpd="sng" algn="ctr">
              <a:solidFill>
                <a:srgbClr val="95A39D"/>
              </a:solidFill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en-GB" sz="1800" b="0" i="0" u="none" strike="noStrike" kern="0" cap="none" spc="0" normalizeH="0" baseline="0" noProof="0">
                <a:ln>
                  <a:noFill/>
                </a:ln>
                <a:solidFill>
                  <a:srgbClr val="2E2B21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391" name="Gerader Verbinder 390"/>
            <p:cNvCxnSpPr/>
            <p:nvPr/>
          </p:nvCxnSpPr>
          <p:spPr>
            <a:xfrm flipV="1">
              <a:off x="1309521" y="4301393"/>
              <a:ext cx="0" cy="270000"/>
            </a:xfrm>
            <a:prstGeom prst="line">
              <a:avLst/>
            </a:prstGeom>
            <a:noFill/>
            <a:ln w="28575" cap="sq" cmpd="sng" algn="ctr">
              <a:solidFill>
                <a:srgbClr val="2E2B21"/>
              </a:solidFill>
              <a:prstDash val="solid"/>
              <a:headEnd type="none" w="med" len="med"/>
              <a:tailEnd type="none" w="med" len="med"/>
            </a:ln>
            <a:effectLst/>
          </p:spPr>
        </p:cxnSp>
        <p:sp>
          <p:nvSpPr>
            <p:cNvPr id="392" name="Textfeld 391"/>
            <p:cNvSpPr txBox="1"/>
            <p:nvPr/>
          </p:nvSpPr>
          <p:spPr>
            <a:xfrm>
              <a:off x="869797" y="3858092"/>
              <a:ext cx="837106" cy="461665"/>
            </a:xfrm>
            <a:prstGeom prst="rect">
              <a:avLst/>
            </a:prstGeom>
            <a:noFill/>
            <a:ln w="3175">
              <a:noFill/>
            </a:ln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>
                <a:defRPr sz="1600"/>
              </a:lvl1pPr>
            </a:lstStyle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r>
                <a:rPr kumimoji="0" lang="en-GB" sz="1200" b="0" i="0" u="none" strike="noStrike" kern="0" cap="none" spc="0" normalizeH="0" baseline="0" noProof="0" dirty="0" err="1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</a:rPr>
                <a:t>Tumor</a:t>
              </a:r>
              <a:r>
                <a:rPr kumimoji="0" lang="en-GB" sz="1200" b="0" i="0" u="none" strike="noStrike" kern="0" cap="none" spc="0" normalizeH="0" baseline="0" noProof="0" dirty="0">
                  <a:ln>
                    <a:noFill/>
                  </a:ln>
                  <a:solidFill>
                    <a:srgbClr val="000000"/>
                  </a:solidFill>
                  <a:effectLst/>
                  <a:uLnTx/>
                  <a:uFillTx/>
                </a:rPr>
                <a:t> initiation</a:t>
              </a:r>
            </a:p>
          </p:txBody>
        </p:sp>
        <p:sp>
          <p:nvSpPr>
            <p:cNvPr id="393" name="Rechteck 392"/>
            <p:cNvSpPr/>
            <p:nvPr/>
          </p:nvSpPr>
          <p:spPr>
            <a:xfrm>
              <a:off x="493894" y="4403407"/>
              <a:ext cx="770878" cy="147731"/>
            </a:xfrm>
            <a:prstGeom prst="rect">
              <a:avLst/>
            </a:prstGeom>
            <a:solidFill>
              <a:srgbClr val="C1D6EF"/>
            </a:solidFill>
            <a:ln w="15875" cap="flat" cmpd="sng" algn="ctr">
              <a:noFill/>
              <a:prstDash val="solid"/>
            </a:ln>
            <a:effectLst/>
          </p:spPr>
          <p:txBody>
            <a:bodyPr rtlCol="0" anchor="ctr"/>
            <a:lstStyle/>
            <a:p>
              <a:pPr marL="0" marR="0" lvl="0" indent="0" algn="ctr" defTabSz="914400" eaLnBrk="1" fontAlgn="auto" latinLnBrk="0" hangingPunct="1">
                <a:lnSpc>
                  <a:spcPct val="100000"/>
                </a:lnSpc>
                <a:spcBef>
                  <a:spcPts val="0"/>
                </a:spcBef>
                <a:spcAft>
                  <a:spcPts val="0"/>
                </a:spcAft>
                <a:buClrTx/>
                <a:buSzTx/>
                <a:buFontTx/>
                <a:buNone/>
                <a:tabLst/>
                <a:defRPr/>
              </a:pPr>
              <a:endParaRPr kumimoji="0" lang="de-DE" sz="1800" b="0" i="0" u="none" strike="noStrike" kern="0" cap="none" spc="0" normalizeH="0" baseline="0" noProof="0">
                <a:ln>
                  <a:noFill/>
                </a:ln>
                <a:solidFill>
                  <a:srgbClr val="FFFF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endParaRPr>
            </a:p>
          </p:txBody>
        </p:sp>
        <p:cxnSp>
          <p:nvCxnSpPr>
            <p:cNvPr id="385" name="Gerader Verbinder 384"/>
            <p:cNvCxnSpPr/>
            <p:nvPr/>
          </p:nvCxnSpPr>
          <p:spPr>
            <a:xfrm flipV="1">
              <a:off x="1267282" y="4301393"/>
              <a:ext cx="0" cy="270000"/>
            </a:xfrm>
            <a:prstGeom prst="line">
              <a:avLst/>
            </a:prstGeom>
            <a:noFill/>
            <a:ln w="28575" cap="sq" cmpd="sng" algn="ctr">
              <a:solidFill>
                <a:srgbClr val="2E2B21"/>
              </a:solidFill>
              <a:prstDash val="solid"/>
              <a:headEnd type="none" w="med" len="med"/>
              <a:tailEnd type="none" w="med" len="med"/>
            </a:ln>
            <a:effectLst/>
          </p:spPr>
        </p:cxnSp>
      </p:grpSp>
      <p:sp>
        <p:nvSpPr>
          <p:cNvPr id="4" name="Textfeld 3">
            <a:extLst>
              <a:ext uri="{FF2B5EF4-FFF2-40B4-BE49-F238E27FC236}">
                <a16:creationId xmlns:a16="http://schemas.microsoft.com/office/drawing/2014/main" id="{FE69CA29-F040-A945-B2D3-EBB612BEC317}"/>
              </a:ext>
            </a:extLst>
          </p:cNvPr>
          <p:cNvSpPr txBox="1"/>
          <p:nvPr/>
        </p:nvSpPr>
        <p:spPr>
          <a:xfrm>
            <a:off x="14872" y="-4155"/>
            <a:ext cx="42641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b="1" dirty="0" smtClean="0"/>
              <a:t>Fig. S1 </a:t>
            </a:r>
            <a:r>
              <a:rPr lang="en-US" sz="1400" dirty="0" smtClean="0"/>
              <a:t>Cell lines at different stages of prostate cancer</a:t>
            </a:r>
            <a:endParaRPr lang="de-DE" sz="1400" dirty="0"/>
          </a:p>
        </p:txBody>
      </p:sp>
    </p:spTree>
    <p:extLst>
      <p:ext uri="{BB962C8B-B14F-4D97-AF65-F5344CB8AC3E}">
        <p14:creationId xmlns:p14="http://schemas.microsoft.com/office/powerpoint/2010/main" val="220308676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8</Words>
  <Application>Microsoft Office PowerPoint</Application>
  <PresentationFormat>Benutzerdefiniert</PresentationFormat>
  <Paragraphs>16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3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Wüstmann, Neele Elisabeth</dc:creator>
  <cp:lastModifiedBy>Wüstmann, Neele Elisabeth</cp:lastModifiedBy>
  <cp:revision>316</cp:revision>
  <cp:lastPrinted>2022-01-26T09:42:13Z</cp:lastPrinted>
  <dcterms:created xsi:type="dcterms:W3CDTF">2021-11-18T14:50:58Z</dcterms:created>
  <dcterms:modified xsi:type="dcterms:W3CDTF">2023-03-07T10:21:23Z</dcterms:modified>
</cp:coreProperties>
</file>